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2" d="100"/>
          <a:sy n="112" d="100"/>
        </p:scale>
        <p:origin x="51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C8ABE92-8E89-4D1A-9F27-D22CBA9338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0819DFF5-0B97-4EF6-A856-5BD40D68ED8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67C1C1B7-72FE-49C2-933D-CBD8CAB8DF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FDFD9-9380-47D9-AF4F-9C7D03E96F3E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EC1CABAC-6A36-48B7-BF19-04BF78617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F2D1BEBF-3345-4D91-8936-CE18E7885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56A2-69A2-495D-AF9F-F3BE01CA6A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9315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6D817C2-5C86-4827-A9FB-22372FA8F1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790B4A8E-CFAC-46A3-B34F-451B2658DC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B0C6316A-4279-4361-A137-3A180AB42D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FDFD9-9380-47D9-AF4F-9C7D03E96F3E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ADB40007-F5FF-4082-820D-B9BD7C5F0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5CCC25E7-6F8A-44C5-8B9D-03CCE5F56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56A2-69A2-495D-AF9F-F3BE01CA6A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64111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6550F6C9-39B4-4D0F-9B48-19A76AFED0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994D3F98-CCDE-4D28-94CC-368D182CC9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A9319275-F2D5-45DD-8796-E18338AB9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FDFD9-9380-47D9-AF4F-9C7D03E96F3E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55F2E074-A829-45BF-8A5E-26656212E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2D3DA691-8E3C-487F-AE33-63132E9641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56A2-69A2-495D-AF9F-F3BE01CA6A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9227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63C3E45-4A7C-45FB-A0AA-87AA1E4006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0E624FC2-811B-473F-A92B-EC318A5DCBC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5BFF4388-096A-44D6-AE60-58797FCE9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FDFD9-9380-47D9-AF4F-9C7D03E96F3E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76D75B0A-0259-4324-AAF0-DE49E3F17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1BB6C131-000F-4C95-9F56-A2769CAA32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56A2-69A2-495D-AF9F-F3BE01CA6A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5603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F25EA15-2425-4E2C-B60E-7FA31FD2B0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18D3DD7F-F58E-4D52-9F94-190CDC0B3D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34428094-1E1B-407C-93BA-F0FA68FE75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FDFD9-9380-47D9-AF4F-9C7D03E96F3E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7C76A386-24DC-4E4D-A3C7-2201123F95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2AE2DEE8-7B01-4B6E-B97B-DA15173B6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56A2-69A2-495D-AF9F-F3BE01CA6A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9796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AE1A168C-DA48-49BB-9115-94A5B1CB1F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ADF48AB0-FF87-4C3A-AE90-0A5ECF5011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D68E5777-31CB-4CA5-9AB8-1974FD4E31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DC816300-2935-42ED-853C-0B5133C71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FDFD9-9380-47D9-AF4F-9C7D03E96F3E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D978A945-9E84-47EE-A40F-618FFA8A4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8E160BC3-6EE3-4800-B3D7-AA15FB21D5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56A2-69A2-495D-AF9F-F3BE01CA6A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5848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ED8DAA1-6C11-46DA-BFA3-7EC548D985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14A863A4-EF80-43EA-B8FF-BDF447BF31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42129563-8488-4631-A2BD-D136C4D103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1D75C059-C6D7-4DD4-9CDB-871537BF4C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75EA17C7-E9DB-46BE-9588-E175CE00B4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FF73EB8E-8715-4326-A593-CC1E1F145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FDFD9-9380-47D9-AF4F-9C7D03E96F3E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610F1AAF-FF1E-4BE3-BA42-4C9D62C365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A2003C7E-899E-4C89-82E7-926D17465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56A2-69A2-495D-AF9F-F3BE01CA6A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0719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E77D3CA-E7EA-4427-B0A7-84387B0BAD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FBD0741C-8750-4BAF-B475-6EED00AB4B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FDFD9-9380-47D9-AF4F-9C7D03E96F3E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C8B31E3C-9AFE-468E-88A5-87EDDF1BE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6CE518FD-57F5-4F9F-85BB-0E426A404F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56A2-69A2-495D-AF9F-F3BE01CA6A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3024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9AFD9D19-1886-4054-B6FE-8F0C223125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FDFD9-9380-47D9-AF4F-9C7D03E96F3E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DA545B49-343C-400C-854F-DABAAEBF1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911AD98B-C1A4-4D0D-9D6D-6794C2381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56A2-69A2-495D-AF9F-F3BE01CA6A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7985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3D08E00-7842-4AB8-B956-05034839EA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3518EF12-3CCE-4338-8BE9-9018AC2B56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DB0F63BA-86BC-4059-9806-D0C5915234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75EE16FA-4070-4442-A441-123220BBB9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FDFD9-9380-47D9-AF4F-9C7D03E96F3E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1E67EA47-5F72-4487-AA68-4E6D366FC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9048E7DA-82CE-4977-BCD2-1FBD764B01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56A2-69A2-495D-AF9F-F3BE01CA6A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2735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C853EF3-54CB-4C9B-9D67-034D917AC4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BCB476B1-1809-4139-9A60-80120C0B3D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FF84293F-025D-415B-9068-2F1A1B7212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1C4B8849-5D03-4379-BB38-2FC12A02B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FDFD9-9380-47D9-AF4F-9C7D03E96F3E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6141E2CC-FE1C-4D07-B4A5-694EE0A1CB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9D9EFD0E-6C19-4C35-A3F1-78030062B3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56A2-69A2-495D-AF9F-F3BE01CA6A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9376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F7AE79EA-A634-4821-8F32-8DBA66DDBA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A3AC978B-2166-4ECD-8D71-BC15D622EB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C46BE164-579C-4759-92AA-535A122AAC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1FDFD9-9380-47D9-AF4F-9C7D03E96F3E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38D46A58-F893-4A79-B835-F4940E94BB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020F368F-B940-4968-B96E-B018CC119C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7D56A2-69A2-495D-AF9F-F3BE01CA6A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62002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4784" b="2393"/>
          <a:stretch/>
        </p:blipFill>
        <p:spPr>
          <a:xfrm>
            <a:off x="785355" y="1009803"/>
            <a:ext cx="5157663" cy="233718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432" t="5325" b="2392"/>
          <a:stretch/>
        </p:blipFill>
        <p:spPr>
          <a:xfrm>
            <a:off x="6488751" y="1023451"/>
            <a:ext cx="5153593" cy="232353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130190CA-7EBE-4498-AD60-8BBEE7DD0DA2}"/>
              </a:ext>
            </a:extLst>
          </p:cNvPr>
          <p:cNvSpPr txBox="1"/>
          <p:nvPr/>
        </p:nvSpPr>
        <p:spPr>
          <a:xfrm>
            <a:off x="1992589" y="592789"/>
            <a:ext cx="26781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dirty="0"/>
              <a:t>All metabolit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AC0049E4-9468-471A-9AFE-DCE9E0F038F2}"/>
              </a:ext>
            </a:extLst>
          </p:cNvPr>
          <p:cNvSpPr txBox="1"/>
          <p:nvPr/>
        </p:nvSpPr>
        <p:spPr>
          <a:xfrm>
            <a:off x="6957688" y="601217"/>
            <a:ext cx="41283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dirty="0"/>
              <a:t>Without </a:t>
            </a:r>
            <a:r>
              <a:rPr lang="en-GB" sz="2400" dirty="0" smtClean="0"/>
              <a:t>carotenoids</a:t>
            </a:r>
            <a:endParaRPr lang="en-GB" sz="2400" dirty="0"/>
          </a:p>
        </p:txBody>
      </p:sp>
      <p:sp>
        <p:nvSpPr>
          <p:cNvPr id="8" name="TextBox 7"/>
          <p:cNvSpPr txBox="1"/>
          <p:nvPr/>
        </p:nvSpPr>
        <p:spPr>
          <a:xfrm>
            <a:off x="125404" y="146304"/>
            <a:ext cx="116089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R</a:t>
            </a:r>
            <a:r>
              <a:rPr lang="en-GB" dirty="0" smtClean="0"/>
              <a:t>ipe stage</a:t>
            </a:r>
            <a:endParaRPr lang="en-GB" dirty="0"/>
          </a:p>
        </p:txBody>
      </p:sp>
      <p:sp>
        <p:nvSpPr>
          <p:cNvPr id="2" name="TextBox 1"/>
          <p:cNvSpPr txBox="1"/>
          <p:nvPr/>
        </p:nvSpPr>
        <p:spPr>
          <a:xfrm>
            <a:off x="413693" y="698043"/>
            <a:ext cx="566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478734" y="4272660"/>
            <a:ext cx="566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4"/>
          <a:srcRect l="2344" t="3379" r="2561" b="3282"/>
          <a:stretch/>
        </p:blipFill>
        <p:spPr>
          <a:xfrm>
            <a:off x="1222538" y="4225608"/>
            <a:ext cx="4833016" cy="2240583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 rot="16200000">
            <a:off x="1961056" y="6247220"/>
            <a:ext cx="428235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GB" sz="1100" dirty="0" smtClean="0">
                <a:solidFill>
                  <a:srgbClr val="C00000"/>
                </a:solidFill>
              </a:rPr>
              <a:t>Keto 1</a:t>
            </a:r>
            <a:endParaRPr lang="en-GB" sz="1100" dirty="0">
              <a:solidFill>
                <a:srgbClr val="C00000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1420998" y="6247219"/>
            <a:ext cx="428235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GB" sz="1100" dirty="0" smtClean="0">
                <a:solidFill>
                  <a:srgbClr val="C00000"/>
                </a:solidFill>
              </a:rPr>
              <a:t>Keto 2</a:t>
            </a:r>
            <a:endParaRPr lang="en-GB" sz="1100" dirty="0">
              <a:solidFill>
                <a:srgbClr val="C00000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2485578" y="6247220"/>
            <a:ext cx="428235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GB" sz="1100" dirty="0" smtClean="0">
                <a:solidFill>
                  <a:srgbClr val="C00000"/>
                </a:solidFill>
              </a:rPr>
              <a:t>Keto 3</a:t>
            </a:r>
            <a:endParaRPr lang="en-GB" sz="1100" dirty="0">
              <a:solidFill>
                <a:srgbClr val="C00000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4551567" y="6304742"/>
            <a:ext cx="543279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l-GR" sz="1100" dirty="0" smtClean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GB" sz="1100" dirty="0" smtClean="0">
                <a:solidFill>
                  <a:schemeClr val="accent2">
                    <a:lumMod val="75000"/>
                  </a:schemeClr>
                </a:solidFill>
                <a:cs typeface="Calibri" panose="020F0502020204030204" pitchFamily="34" charset="0"/>
              </a:rPr>
              <a:t>-</a:t>
            </a:r>
            <a:r>
              <a:rPr lang="en-GB" sz="1100" dirty="0" err="1" smtClean="0">
                <a:solidFill>
                  <a:schemeClr val="accent2">
                    <a:lumMod val="75000"/>
                  </a:schemeClr>
                </a:solidFill>
                <a:cs typeface="Calibri" panose="020F0502020204030204" pitchFamily="34" charset="0"/>
              </a:rPr>
              <a:t>caro</a:t>
            </a:r>
            <a:r>
              <a:rPr lang="en-GB" sz="1100" dirty="0" smtClean="0">
                <a:solidFill>
                  <a:schemeClr val="accent2">
                    <a:lumMod val="75000"/>
                  </a:schemeClr>
                </a:solidFill>
              </a:rPr>
              <a:t> 1</a:t>
            </a:r>
            <a:endParaRPr lang="en-GB" sz="1100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5094585" y="6304742"/>
            <a:ext cx="543279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l-GR" sz="1100" dirty="0" smtClean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GB" sz="1100" dirty="0" smtClean="0">
                <a:solidFill>
                  <a:schemeClr val="accent2">
                    <a:lumMod val="75000"/>
                  </a:schemeClr>
                </a:solidFill>
                <a:cs typeface="Calibri" panose="020F0502020204030204" pitchFamily="34" charset="0"/>
              </a:rPr>
              <a:t>-</a:t>
            </a:r>
            <a:r>
              <a:rPr lang="en-GB" sz="1100" dirty="0" err="1" smtClean="0">
                <a:solidFill>
                  <a:schemeClr val="accent2">
                    <a:lumMod val="75000"/>
                  </a:schemeClr>
                </a:solidFill>
                <a:cs typeface="Calibri" panose="020F0502020204030204" pitchFamily="34" charset="0"/>
              </a:rPr>
              <a:t>caro</a:t>
            </a:r>
            <a:r>
              <a:rPr lang="en-GB" sz="1100" dirty="0" smtClean="0">
                <a:solidFill>
                  <a:schemeClr val="accent2">
                    <a:lumMod val="75000"/>
                  </a:schemeClr>
                </a:solidFill>
              </a:rPr>
              <a:t> 2</a:t>
            </a:r>
            <a:endParaRPr lang="en-GB" sz="1100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5611709" y="6304742"/>
            <a:ext cx="543279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l-GR" sz="1100" dirty="0" smtClean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GB" sz="1100" dirty="0" smtClean="0">
                <a:solidFill>
                  <a:schemeClr val="accent2">
                    <a:lumMod val="75000"/>
                  </a:schemeClr>
                </a:solidFill>
                <a:cs typeface="Calibri" panose="020F0502020204030204" pitchFamily="34" charset="0"/>
              </a:rPr>
              <a:t>-</a:t>
            </a:r>
            <a:r>
              <a:rPr lang="en-GB" sz="1100" dirty="0" err="1" smtClean="0">
                <a:solidFill>
                  <a:schemeClr val="accent2">
                    <a:lumMod val="75000"/>
                  </a:schemeClr>
                </a:solidFill>
                <a:cs typeface="Calibri" panose="020F0502020204030204" pitchFamily="34" charset="0"/>
              </a:rPr>
              <a:t>caro</a:t>
            </a:r>
            <a:r>
              <a:rPr lang="en-GB" sz="1100" dirty="0" smtClean="0">
                <a:solidFill>
                  <a:schemeClr val="accent2">
                    <a:lumMod val="75000"/>
                  </a:schemeClr>
                </a:solidFill>
              </a:rPr>
              <a:t> 3</a:t>
            </a:r>
            <a:endParaRPr lang="en-GB" sz="1100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3502996" y="6304741"/>
            <a:ext cx="543279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GB" sz="1100" dirty="0" smtClean="0">
                <a:solidFill>
                  <a:schemeClr val="bg2">
                    <a:lumMod val="50000"/>
                  </a:schemeClr>
                </a:solidFill>
              </a:rPr>
              <a:t>Control 1</a:t>
            </a:r>
            <a:endParaRPr lang="en-GB" sz="1100" dirty="0">
              <a:solidFill>
                <a:schemeClr val="bg2">
                  <a:lumMod val="50000"/>
                </a:schemeClr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2951841" y="6304741"/>
            <a:ext cx="543279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GB" sz="1100" dirty="0" smtClean="0">
                <a:solidFill>
                  <a:schemeClr val="bg2">
                    <a:lumMod val="50000"/>
                  </a:schemeClr>
                </a:solidFill>
              </a:rPr>
              <a:t>Control 2</a:t>
            </a:r>
            <a:endParaRPr lang="en-GB" sz="1100" dirty="0">
              <a:solidFill>
                <a:schemeClr val="bg2">
                  <a:lumMod val="50000"/>
                </a:schemeClr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4010503" y="6304742"/>
            <a:ext cx="543279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GB" sz="1100" dirty="0" smtClean="0">
                <a:solidFill>
                  <a:schemeClr val="bg2">
                    <a:lumMod val="50000"/>
                  </a:schemeClr>
                </a:solidFill>
              </a:rPr>
              <a:t>Control 3</a:t>
            </a:r>
            <a:endParaRPr lang="en-GB" sz="1100" dirty="0">
              <a:solidFill>
                <a:schemeClr val="bg2">
                  <a:lumMod val="50000"/>
                </a:schemeClr>
              </a:solidFill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130190CA-7EBE-4498-AD60-8BBEE7DD0DA2}"/>
              </a:ext>
            </a:extLst>
          </p:cNvPr>
          <p:cNvSpPr txBox="1"/>
          <p:nvPr/>
        </p:nvSpPr>
        <p:spPr>
          <a:xfrm>
            <a:off x="1941789" y="3687525"/>
            <a:ext cx="26781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dirty="0"/>
              <a:t>All metabolites</a:t>
            </a:r>
          </a:p>
        </p:txBody>
      </p:sp>
    </p:spTree>
    <p:extLst>
      <p:ext uri="{BB962C8B-B14F-4D97-AF65-F5344CB8AC3E}">
        <p14:creationId xmlns:p14="http://schemas.microsoft.com/office/powerpoint/2010/main" val="940470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</TotalTime>
  <Words>31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gueira, Marilise</dc:creator>
  <cp:lastModifiedBy>marilise nogueira</cp:lastModifiedBy>
  <cp:revision>17</cp:revision>
  <cp:lastPrinted>2021-10-04T15:34:59Z</cp:lastPrinted>
  <dcterms:created xsi:type="dcterms:W3CDTF">2021-10-04T14:53:52Z</dcterms:created>
  <dcterms:modified xsi:type="dcterms:W3CDTF">2022-10-20T15:53:46Z</dcterms:modified>
</cp:coreProperties>
</file>